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346" r:id="rId6"/>
    <p:sldId id="339" r:id="rId7"/>
    <p:sldId id="347" r:id="rId8"/>
    <p:sldId id="348" r:id="rId9"/>
    <p:sldId id="349" r:id="rId10"/>
    <p:sldId id="343" r:id="rId11"/>
    <p:sldId id="344" r:id="rId12"/>
    <p:sldId id="345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04" userDrawn="1">
          <p15:clr>
            <a:srgbClr val="A4A3A4"/>
          </p15:clr>
        </p15:guide>
        <p15:guide id="2" pos="3114" userDrawn="1">
          <p15:clr>
            <a:srgbClr val="A4A3A4"/>
          </p15:clr>
        </p15:guide>
        <p15:guide id="3" pos="960" userDrawn="1">
          <p15:clr>
            <a:srgbClr val="A4A3A4"/>
          </p15:clr>
        </p15:guide>
        <p15:guide id="4" pos="1345" userDrawn="1">
          <p15:clr>
            <a:srgbClr val="A4A3A4"/>
          </p15:clr>
        </p15:guide>
        <p15:guide id="5" orient="horz" pos="1253" userDrawn="1">
          <p15:clr>
            <a:srgbClr val="A4A3A4"/>
          </p15:clr>
        </p15:guide>
        <p15:guide id="6" orient="horz" pos="845" userDrawn="1">
          <p15:clr>
            <a:srgbClr val="A4A3A4"/>
          </p15:clr>
        </p15:guide>
        <p15:guide id="7" pos="454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116D88C-EB38-43C1-A753-A1A67ECE8C2C}" v="52" dt="2025-08-07T14:25:51.5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66" autoAdjust="0"/>
    <p:restoredTop sz="94632"/>
  </p:normalViewPr>
  <p:slideViewPr>
    <p:cSldViewPr snapToGrid="0">
      <p:cViewPr>
        <p:scale>
          <a:sx n="110" d="100"/>
          <a:sy n="110" d="100"/>
        </p:scale>
        <p:origin x="-789" y="-636"/>
      </p:cViewPr>
      <p:guideLst>
        <p:guide orient="horz" pos="2704"/>
        <p:guide pos="3114"/>
        <p:guide pos="960"/>
        <p:guide pos="1345"/>
        <p:guide orient="horz" pos="1253"/>
        <p:guide orient="horz" pos="845"/>
        <p:guide pos="454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evens, Meg" userId="02054468-babb-4f50-a3f3-e6523456c3f9" providerId="ADAL" clId="{3116D88C-EB38-43C1-A753-A1A67ECE8C2C}"/>
    <pc:docChg chg="undo custSel modSld">
      <pc:chgData name="Stevens, Meg" userId="02054468-babb-4f50-a3f3-e6523456c3f9" providerId="ADAL" clId="{3116D88C-EB38-43C1-A753-A1A67ECE8C2C}" dt="2025-08-07T15:42:32.639" v="1402" actId="20577"/>
      <pc:docMkLst>
        <pc:docMk/>
      </pc:docMkLst>
      <pc:sldChg chg="modSp mod">
        <pc:chgData name="Stevens, Meg" userId="02054468-babb-4f50-a3f3-e6523456c3f9" providerId="ADAL" clId="{3116D88C-EB38-43C1-A753-A1A67ECE8C2C}" dt="2025-08-07T15:31:14.553" v="1335" actId="20577"/>
        <pc:sldMkLst>
          <pc:docMk/>
          <pc:sldMk cId="4209708433" sldId="256"/>
        </pc:sldMkLst>
        <pc:spChg chg="mod">
          <ac:chgData name="Stevens, Meg" userId="02054468-babb-4f50-a3f3-e6523456c3f9" providerId="ADAL" clId="{3116D88C-EB38-43C1-A753-A1A67ECE8C2C}" dt="2025-08-07T15:31:14.553" v="1335" actId="20577"/>
          <ac:spMkLst>
            <pc:docMk/>
            <pc:sldMk cId="4209708433" sldId="256"/>
            <ac:spMk id="8" creationId="{4DF7D02B-C4D0-6F77-56CF-B828A02ECF15}"/>
          </ac:spMkLst>
        </pc:spChg>
      </pc:sldChg>
      <pc:sldChg chg="modSp mod">
        <pc:chgData name="Stevens, Meg" userId="02054468-babb-4f50-a3f3-e6523456c3f9" providerId="ADAL" clId="{3116D88C-EB38-43C1-A753-A1A67ECE8C2C}" dt="2025-08-07T15:31:34.171" v="1358" actId="20577"/>
        <pc:sldMkLst>
          <pc:docMk/>
          <pc:sldMk cId="3675509514" sldId="257"/>
        </pc:sldMkLst>
        <pc:spChg chg="mod">
          <ac:chgData name="Stevens, Meg" userId="02054468-babb-4f50-a3f3-e6523456c3f9" providerId="ADAL" clId="{3116D88C-EB38-43C1-A753-A1A67ECE8C2C}" dt="2025-08-07T15:31:34.171" v="1358" actId="20577"/>
          <ac:spMkLst>
            <pc:docMk/>
            <pc:sldMk cId="3675509514" sldId="257"/>
            <ac:spMk id="6" creationId="{22FE47FD-4B0B-E066-E64D-5CC0F8670B7C}"/>
          </ac:spMkLst>
        </pc:spChg>
      </pc:sldChg>
      <pc:sldChg chg="addSp delSp modSp mod">
        <pc:chgData name="Stevens, Meg" userId="02054468-babb-4f50-a3f3-e6523456c3f9" providerId="ADAL" clId="{3116D88C-EB38-43C1-A753-A1A67ECE8C2C}" dt="2025-08-07T15:30:34.869" v="1306" actId="20577"/>
        <pc:sldMkLst>
          <pc:docMk/>
          <pc:sldMk cId="2915873751" sldId="258"/>
        </pc:sldMkLst>
        <pc:spChg chg="mod">
          <ac:chgData name="Stevens, Meg" userId="02054468-babb-4f50-a3f3-e6523456c3f9" providerId="ADAL" clId="{3116D88C-EB38-43C1-A753-A1A67ECE8C2C}" dt="2025-08-07T15:30:34.869" v="1306" actId="20577"/>
          <ac:spMkLst>
            <pc:docMk/>
            <pc:sldMk cId="2915873751" sldId="258"/>
            <ac:spMk id="8" creationId="{4DF7D02B-C4D0-6F77-56CF-B828A02ECF15}"/>
          </ac:spMkLst>
        </pc:spChg>
        <pc:graphicFrameChg chg="add mod">
          <ac:chgData name="Stevens, Meg" userId="02054468-babb-4f50-a3f3-e6523456c3f9" providerId="ADAL" clId="{3116D88C-EB38-43C1-A753-A1A67ECE8C2C}" dt="2025-08-05T15:34:41.096" v="125" actId="1076"/>
          <ac:graphicFrameMkLst>
            <pc:docMk/>
            <pc:sldMk cId="2915873751" sldId="258"/>
            <ac:graphicFrameMk id="4" creationId="{34E391C6-A137-DE74-9967-36132DF4F020}"/>
          </ac:graphicFrameMkLst>
        </pc:graphicFrameChg>
      </pc:sldChg>
      <pc:sldChg chg="addSp delSp modSp mod">
        <pc:chgData name="Stevens, Meg" userId="02054468-babb-4f50-a3f3-e6523456c3f9" providerId="ADAL" clId="{3116D88C-EB38-43C1-A753-A1A67ECE8C2C}" dt="2025-08-05T15:38:40.002" v="206" actId="14100"/>
        <pc:sldMkLst>
          <pc:docMk/>
          <pc:sldMk cId="1157780288" sldId="259"/>
        </pc:sldMkLst>
        <pc:spChg chg="mod">
          <ac:chgData name="Stevens, Meg" userId="02054468-babb-4f50-a3f3-e6523456c3f9" providerId="ADAL" clId="{3116D88C-EB38-43C1-A753-A1A67ECE8C2C}" dt="2025-08-05T15:38:31.490" v="202" actId="20577"/>
          <ac:spMkLst>
            <pc:docMk/>
            <pc:sldMk cId="1157780288" sldId="259"/>
            <ac:spMk id="6" creationId="{22FE47FD-4B0B-E066-E64D-5CC0F8670B7C}"/>
          </ac:spMkLst>
        </pc:spChg>
        <pc:graphicFrameChg chg="add mod">
          <ac:chgData name="Stevens, Meg" userId="02054468-babb-4f50-a3f3-e6523456c3f9" providerId="ADAL" clId="{3116D88C-EB38-43C1-A753-A1A67ECE8C2C}" dt="2025-08-05T15:38:40.002" v="206" actId="14100"/>
          <ac:graphicFrameMkLst>
            <pc:docMk/>
            <pc:sldMk cId="1157780288" sldId="259"/>
            <ac:graphicFrameMk id="3" creationId="{C773E75D-CEFF-3B65-168D-DA00C87D3A2A}"/>
          </ac:graphicFrameMkLst>
        </pc:graphicFrameChg>
      </pc:sldChg>
      <pc:sldChg chg="modSp mod">
        <pc:chgData name="Stevens, Meg" userId="02054468-babb-4f50-a3f3-e6523456c3f9" providerId="ADAL" clId="{3116D88C-EB38-43C1-A753-A1A67ECE8C2C}" dt="2025-08-07T15:42:32.639" v="1402" actId="20577"/>
        <pc:sldMkLst>
          <pc:docMk/>
          <pc:sldMk cId="2817670373" sldId="339"/>
        </pc:sldMkLst>
        <pc:spChg chg="mod">
          <ac:chgData name="Stevens, Meg" userId="02054468-babb-4f50-a3f3-e6523456c3f9" providerId="ADAL" clId="{3116D88C-EB38-43C1-A753-A1A67ECE8C2C}" dt="2025-08-07T15:42:32.639" v="1402" actId="20577"/>
          <ac:spMkLst>
            <pc:docMk/>
            <pc:sldMk cId="2817670373" sldId="339"/>
            <ac:spMk id="6" creationId="{5CF63D90-111D-F1B1-EA55-80C5AF913FA5}"/>
          </ac:spMkLst>
        </pc:spChg>
        <pc:spChg chg="mod">
          <ac:chgData name="Stevens, Meg" userId="02054468-babb-4f50-a3f3-e6523456c3f9" providerId="ADAL" clId="{3116D88C-EB38-43C1-A753-A1A67ECE8C2C}" dt="2025-08-05T15:41:35.312" v="319" actId="20577"/>
          <ac:spMkLst>
            <pc:docMk/>
            <pc:sldMk cId="2817670373" sldId="339"/>
            <ac:spMk id="8" creationId="{0BB775A6-5AE3-8714-FAC3-8EF3AF83BB0B}"/>
          </ac:spMkLst>
        </pc:spChg>
        <pc:spChg chg="mod">
          <ac:chgData name="Stevens, Meg" userId="02054468-babb-4f50-a3f3-e6523456c3f9" providerId="ADAL" clId="{3116D88C-EB38-43C1-A753-A1A67ECE8C2C}" dt="2025-08-05T15:41:41.529" v="329" actId="20577"/>
          <ac:spMkLst>
            <pc:docMk/>
            <pc:sldMk cId="2817670373" sldId="339"/>
            <ac:spMk id="9" creationId="{E626DD58-2C35-9942-71A9-034966137966}"/>
          </ac:spMkLst>
        </pc:spChg>
      </pc:sldChg>
      <pc:sldChg chg="addSp delSp modSp mod">
        <pc:chgData name="Stevens, Meg" userId="02054468-babb-4f50-a3f3-e6523456c3f9" providerId="ADAL" clId="{3116D88C-EB38-43C1-A753-A1A67ECE8C2C}" dt="2025-08-07T14:09:00.259" v="918" actId="1076"/>
        <pc:sldMkLst>
          <pc:docMk/>
          <pc:sldMk cId="997741743" sldId="343"/>
        </pc:sldMkLst>
        <pc:spChg chg="mod">
          <ac:chgData name="Stevens, Meg" userId="02054468-babb-4f50-a3f3-e6523456c3f9" providerId="ADAL" clId="{3116D88C-EB38-43C1-A753-A1A67ECE8C2C}" dt="2025-08-07T14:06:01.859" v="907" actId="20577"/>
          <ac:spMkLst>
            <pc:docMk/>
            <pc:sldMk cId="997741743" sldId="343"/>
            <ac:spMk id="8" creationId="{C9B36E3D-65EE-BF9A-E05E-EDE0B2B15799}"/>
          </ac:spMkLst>
        </pc:spChg>
        <pc:graphicFrameChg chg="add mod">
          <ac:chgData name="Stevens, Meg" userId="02054468-babb-4f50-a3f3-e6523456c3f9" providerId="ADAL" clId="{3116D88C-EB38-43C1-A753-A1A67ECE8C2C}" dt="2025-08-07T14:07:15.562" v="913" actId="14100"/>
          <ac:graphicFrameMkLst>
            <pc:docMk/>
            <pc:sldMk cId="997741743" sldId="343"/>
            <ac:graphicFrameMk id="14" creationId="{0DB724E8-925C-1243-A018-197101A6F81B}"/>
          </ac:graphicFrameMkLst>
        </pc:graphicFrameChg>
        <pc:graphicFrameChg chg="add mod">
          <ac:chgData name="Stevens, Meg" userId="02054468-babb-4f50-a3f3-e6523456c3f9" providerId="ADAL" clId="{3116D88C-EB38-43C1-A753-A1A67ECE8C2C}" dt="2025-08-07T14:09:00.259" v="918" actId="1076"/>
          <ac:graphicFrameMkLst>
            <pc:docMk/>
            <pc:sldMk cId="997741743" sldId="343"/>
            <ac:graphicFrameMk id="15" creationId="{11A20C35-8589-15EF-2F76-53907CB607AE}"/>
          </ac:graphicFrameMkLst>
        </pc:graphicFrameChg>
        <pc:picChg chg="del">
          <ac:chgData name="Stevens, Meg" userId="02054468-babb-4f50-a3f3-e6523456c3f9" providerId="ADAL" clId="{3116D88C-EB38-43C1-A753-A1A67ECE8C2C}" dt="2025-08-07T14:08:48.462" v="914" actId="478"/>
          <ac:picMkLst>
            <pc:docMk/>
            <pc:sldMk cId="997741743" sldId="343"/>
            <ac:picMk id="6" creationId="{00000000-0000-0000-0000-000000000000}"/>
          </ac:picMkLst>
        </pc:picChg>
        <pc:picChg chg="del">
          <ac:chgData name="Stevens, Meg" userId="02054468-babb-4f50-a3f3-e6523456c3f9" providerId="ADAL" clId="{3116D88C-EB38-43C1-A753-A1A67ECE8C2C}" dt="2025-08-07T14:07:05.377" v="908" actId="478"/>
          <ac:picMkLst>
            <pc:docMk/>
            <pc:sldMk cId="997741743" sldId="343"/>
            <ac:picMk id="12" creationId="{00000000-0000-0000-0000-000000000000}"/>
          </ac:picMkLst>
        </pc:picChg>
      </pc:sldChg>
      <pc:sldChg chg="addSp delSp modSp mod">
        <pc:chgData name="Stevens, Meg" userId="02054468-babb-4f50-a3f3-e6523456c3f9" providerId="ADAL" clId="{3116D88C-EB38-43C1-A753-A1A67ECE8C2C}" dt="2025-08-07T15:32:15.280" v="1391" actId="20577"/>
        <pc:sldMkLst>
          <pc:docMk/>
          <pc:sldMk cId="3394398120" sldId="344"/>
        </pc:sldMkLst>
        <pc:spChg chg="mod">
          <ac:chgData name="Stevens, Meg" userId="02054468-babb-4f50-a3f3-e6523456c3f9" providerId="ADAL" clId="{3116D88C-EB38-43C1-A753-A1A67ECE8C2C}" dt="2025-08-07T15:32:15.280" v="1391" actId="20577"/>
          <ac:spMkLst>
            <pc:docMk/>
            <pc:sldMk cId="3394398120" sldId="344"/>
            <ac:spMk id="8" creationId="{C9B36E3D-65EE-BF9A-E05E-EDE0B2B15799}"/>
          </ac:spMkLst>
        </pc:spChg>
        <pc:graphicFrameChg chg="add mod">
          <ac:chgData name="Stevens, Meg" userId="02054468-babb-4f50-a3f3-e6523456c3f9" providerId="ADAL" clId="{3116D88C-EB38-43C1-A753-A1A67ECE8C2C}" dt="2025-08-07T14:16:58.716" v="1255" actId="1076"/>
          <ac:graphicFrameMkLst>
            <pc:docMk/>
            <pc:sldMk cId="3394398120" sldId="344"/>
            <ac:graphicFrameMk id="6" creationId="{249F2C8E-FCA4-D7D8-C692-85007DA53712}"/>
          </ac:graphicFrameMkLst>
        </pc:graphicFrameChg>
        <pc:graphicFrameChg chg="del">
          <ac:chgData name="Stevens, Meg" userId="02054468-babb-4f50-a3f3-e6523456c3f9" providerId="ADAL" clId="{3116D88C-EB38-43C1-A753-A1A67ECE8C2C}" dt="2025-08-07T14:16:48.667" v="1251" actId="478"/>
          <ac:graphicFrameMkLst>
            <pc:docMk/>
            <pc:sldMk cId="3394398120" sldId="344"/>
            <ac:graphicFrameMk id="15" creationId="{6224A7EC-EA2B-59A0-1AF3-3246009FFEBF}"/>
          </ac:graphicFrameMkLst>
        </pc:graphicFrameChg>
      </pc:sldChg>
      <pc:sldChg chg="addSp delSp modSp mod">
        <pc:chgData name="Stevens, Meg" userId="02054468-babb-4f50-a3f3-e6523456c3f9" providerId="ADAL" clId="{3116D88C-EB38-43C1-A753-A1A67ECE8C2C}" dt="2025-08-07T14:25:58.885" v="1286" actId="1076"/>
        <pc:sldMkLst>
          <pc:docMk/>
          <pc:sldMk cId="3219659230" sldId="345"/>
        </pc:sldMkLst>
        <pc:spChg chg="mod">
          <ac:chgData name="Stevens, Meg" userId="02054468-babb-4f50-a3f3-e6523456c3f9" providerId="ADAL" clId="{3116D88C-EB38-43C1-A753-A1A67ECE8C2C}" dt="2025-08-07T14:24:58.583" v="1269" actId="20577"/>
          <ac:spMkLst>
            <pc:docMk/>
            <pc:sldMk cId="3219659230" sldId="345"/>
            <ac:spMk id="8" creationId="{C9B36E3D-65EE-BF9A-E05E-EDE0B2B15799}"/>
          </ac:spMkLst>
        </pc:spChg>
        <pc:spChg chg="del">
          <ac:chgData name="Stevens, Meg" userId="02054468-babb-4f50-a3f3-e6523456c3f9" providerId="ADAL" clId="{3116D88C-EB38-43C1-A753-A1A67ECE8C2C}" dt="2025-08-07T14:22:27.221" v="1257" actId="478"/>
          <ac:spMkLst>
            <pc:docMk/>
            <pc:sldMk cId="3219659230" sldId="345"/>
            <ac:spMk id="20" creationId="{43EA4206-6C63-EA45-8623-00B57A6687E8}"/>
          </ac:spMkLst>
        </pc:spChg>
        <pc:spChg chg="del">
          <ac:chgData name="Stevens, Meg" userId="02054468-babb-4f50-a3f3-e6523456c3f9" providerId="ADAL" clId="{3116D88C-EB38-43C1-A753-A1A67ECE8C2C}" dt="2025-08-07T14:24:27.608" v="1261" actId="478"/>
          <ac:spMkLst>
            <pc:docMk/>
            <pc:sldMk cId="3219659230" sldId="345"/>
            <ac:spMk id="21" creationId="{D4E125C4-C041-674B-EFCB-4DA5FAE45441}"/>
          </ac:spMkLst>
        </pc:spChg>
        <pc:spChg chg="add mod">
          <ac:chgData name="Stevens, Meg" userId="02054468-babb-4f50-a3f3-e6523456c3f9" providerId="ADAL" clId="{3116D88C-EB38-43C1-A753-A1A67ECE8C2C}" dt="2025-08-07T14:25:48.067" v="1283" actId="1076"/>
          <ac:spMkLst>
            <pc:docMk/>
            <pc:sldMk cId="3219659230" sldId="345"/>
            <ac:spMk id="25" creationId="{1A8962F5-0425-AF79-6891-E25912795FDF}"/>
          </ac:spMkLst>
        </pc:spChg>
        <pc:spChg chg="add mod">
          <ac:chgData name="Stevens, Meg" userId="02054468-babb-4f50-a3f3-e6523456c3f9" providerId="ADAL" clId="{3116D88C-EB38-43C1-A753-A1A67ECE8C2C}" dt="2025-08-07T14:25:58.885" v="1286" actId="1076"/>
          <ac:spMkLst>
            <pc:docMk/>
            <pc:sldMk cId="3219659230" sldId="345"/>
            <ac:spMk id="27" creationId="{3F187B45-D9DB-886F-1533-0BC8706C150F}"/>
          </ac:spMkLst>
        </pc:spChg>
        <pc:graphicFrameChg chg="add mod">
          <ac:chgData name="Stevens, Meg" userId="02054468-babb-4f50-a3f3-e6523456c3f9" providerId="ADAL" clId="{3116D88C-EB38-43C1-A753-A1A67ECE8C2C}" dt="2025-08-07T14:22:33.740" v="1259" actId="1076"/>
          <ac:graphicFrameMkLst>
            <pc:docMk/>
            <pc:sldMk cId="3219659230" sldId="345"/>
            <ac:graphicFrameMk id="6" creationId="{A6F8EB9A-4CB6-52D2-0F25-469ABB16CEAF}"/>
          </ac:graphicFrameMkLst>
        </pc:graphicFrameChg>
        <pc:graphicFrameChg chg="del">
          <ac:chgData name="Stevens, Meg" userId="02054468-babb-4f50-a3f3-e6523456c3f9" providerId="ADAL" clId="{3116D88C-EB38-43C1-A753-A1A67ECE8C2C}" dt="2025-08-07T14:22:24.575" v="1256" actId="478"/>
          <ac:graphicFrameMkLst>
            <pc:docMk/>
            <pc:sldMk cId="3219659230" sldId="345"/>
            <ac:graphicFrameMk id="14" creationId="{61A1CD0D-E526-CA4E-52EA-F3AB17880F47}"/>
          </ac:graphicFrameMkLst>
        </pc:graphicFrameChg>
        <pc:graphicFrameChg chg="add mod">
          <ac:chgData name="Stevens, Meg" userId="02054468-babb-4f50-a3f3-e6523456c3f9" providerId="ADAL" clId="{3116D88C-EB38-43C1-A753-A1A67ECE8C2C}" dt="2025-08-07T14:24:39.349" v="1263" actId="1076"/>
          <ac:graphicFrameMkLst>
            <pc:docMk/>
            <pc:sldMk cId="3219659230" sldId="345"/>
            <ac:graphicFrameMk id="15" creationId="{2F206CB8-DA77-54FD-F4FF-CE465C1765F8}"/>
          </ac:graphicFrameMkLst>
        </pc:graphicFrameChg>
        <pc:graphicFrameChg chg="del">
          <ac:chgData name="Stevens, Meg" userId="02054468-babb-4f50-a3f3-e6523456c3f9" providerId="ADAL" clId="{3116D88C-EB38-43C1-A753-A1A67ECE8C2C}" dt="2025-08-07T14:24:25.580" v="1260" actId="478"/>
          <ac:graphicFrameMkLst>
            <pc:docMk/>
            <pc:sldMk cId="3219659230" sldId="345"/>
            <ac:graphicFrameMk id="19" creationId="{B797F093-339B-A3F8-7542-769FA3361A2D}"/>
          </ac:graphicFrameMkLst>
        </pc:graphicFrameChg>
        <pc:cxnChg chg="add mod">
          <ac:chgData name="Stevens, Meg" userId="02054468-babb-4f50-a3f3-e6523456c3f9" providerId="ADAL" clId="{3116D88C-EB38-43C1-A753-A1A67ECE8C2C}" dt="2025-08-07T14:25:36.366" v="1278" actId="1037"/>
          <ac:cxnSpMkLst>
            <pc:docMk/>
            <pc:sldMk cId="3219659230" sldId="345"/>
            <ac:cxnSpMk id="22" creationId="{460D2D08-E284-1DCE-DB13-2AB51BCB9FC2}"/>
          </ac:cxnSpMkLst>
        </pc:cxnChg>
        <pc:cxnChg chg="add mod">
          <ac:chgData name="Stevens, Meg" userId="02054468-babb-4f50-a3f3-e6523456c3f9" providerId="ADAL" clId="{3116D88C-EB38-43C1-A753-A1A67ECE8C2C}" dt="2025-08-07T14:25:58.885" v="1286" actId="1076"/>
          <ac:cxnSpMkLst>
            <pc:docMk/>
            <pc:sldMk cId="3219659230" sldId="345"/>
            <ac:cxnSpMk id="26" creationId="{61BE2684-9FAA-C1F8-FCA9-139CEB8FCE32}"/>
          </ac:cxnSpMkLst>
        </pc:cxnChg>
      </pc:sldChg>
      <pc:sldChg chg="modSp mod">
        <pc:chgData name="Stevens, Meg" userId="02054468-babb-4f50-a3f3-e6523456c3f9" providerId="ADAL" clId="{3116D88C-EB38-43C1-A753-A1A67ECE8C2C}" dt="2025-08-05T15:40:20.516" v="275" actId="20577"/>
        <pc:sldMkLst>
          <pc:docMk/>
          <pc:sldMk cId="475526896" sldId="346"/>
        </pc:sldMkLst>
        <pc:spChg chg="mod">
          <ac:chgData name="Stevens, Meg" userId="02054468-babb-4f50-a3f3-e6523456c3f9" providerId="ADAL" clId="{3116D88C-EB38-43C1-A753-A1A67ECE8C2C}" dt="2025-08-05T15:39:46.198" v="274" actId="20577"/>
          <ac:spMkLst>
            <pc:docMk/>
            <pc:sldMk cId="475526896" sldId="346"/>
            <ac:spMk id="3" creationId="{F03E603E-AE8F-655E-0534-7552E7B4A361}"/>
          </ac:spMkLst>
        </pc:spChg>
        <pc:spChg chg="mod">
          <ac:chgData name="Stevens, Meg" userId="02054468-babb-4f50-a3f3-e6523456c3f9" providerId="ADAL" clId="{3116D88C-EB38-43C1-A753-A1A67ECE8C2C}" dt="2025-08-05T15:40:20.516" v="275" actId="20577"/>
          <ac:spMkLst>
            <pc:docMk/>
            <pc:sldMk cId="475526896" sldId="346"/>
            <ac:spMk id="4" creationId="{1BFEE1D3-680B-7645-FF54-E79D2984A04D}"/>
          </ac:spMkLst>
        </pc:spChg>
      </pc:sldChg>
      <pc:sldChg chg="addSp modSp mod">
        <pc:chgData name="Stevens, Meg" userId="02054468-babb-4f50-a3f3-e6523456c3f9" providerId="ADAL" clId="{3116D88C-EB38-43C1-A753-A1A67ECE8C2C}" dt="2025-08-07T13:58:41.773" v="662" actId="1076"/>
        <pc:sldMkLst>
          <pc:docMk/>
          <pc:sldMk cId="4038195431" sldId="347"/>
        </pc:sldMkLst>
        <pc:spChg chg="add mod">
          <ac:chgData name="Stevens, Meg" userId="02054468-babb-4f50-a3f3-e6523456c3f9" providerId="ADAL" clId="{3116D88C-EB38-43C1-A753-A1A67ECE8C2C}" dt="2025-08-07T13:56:57.950" v="586" actId="1076"/>
          <ac:spMkLst>
            <pc:docMk/>
            <pc:sldMk cId="4038195431" sldId="347"/>
            <ac:spMk id="2" creationId="{A9234E80-6F0C-675A-8B74-0862F5A7C25B}"/>
          </ac:spMkLst>
        </pc:spChg>
        <pc:spChg chg="add mod">
          <ac:chgData name="Stevens, Meg" userId="02054468-babb-4f50-a3f3-e6523456c3f9" providerId="ADAL" clId="{3116D88C-EB38-43C1-A753-A1A67ECE8C2C}" dt="2025-08-07T13:57:16.615" v="610" actId="1035"/>
          <ac:spMkLst>
            <pc:docMk/>
            <pc:sldMk cId="4038195431" sldId="347"/>
            <ac:spMk id="3" creationId="{58A1502A-4D4B-A906-44B2-5B197059F95A}"/>
          </ac:spMkLst>
        </pc:spChg>
        <pc:spChg chg="add mod">
          <ac:chgData name="Stevens, Meg" userId="02054468-babb-4f50-a3f3-e6523456c3f9" providerId="ADAL" clId="{3116D88C-EB38-43C1-A753-A1A67ECE8C2C}" dt="2025-08-07T13:58:32.049" v="660" actId="1076"/>
          <ac:spMkLst>
            <pc:docMk/>
            <pc:sldMk cId="4038195431" sldId="347"/>
            <ac:spMk id="5" creationId="{E6763F94-2704-ABAE-F374-0B431B6D4D01}"/>
          </ac:spMkLst>
        </pc:spChg>
        <pc:spChg chg="add mod">
          <ac:chgData name="Stevens, Meg" userId="02054468-babb-4f50-a3f3-e6523456c3f9" providerId="ADAL" clId="{3116D88C-EB38-43C1-A753-A1A67ECE8C2C}" dt="2025-08-07T13:58:41.773" v="662" actId="1076"/>
          <ac:spMkLst>
            <pc:docMk/>
            <pc:sldMk cId="4038195431" sldId="347"/>
            <ac:spMk id="6" creationId="{AA5E4846-75B3-4FF6-CCAD-18814C234D5B}"/>
          </ac:spMkLst>
        </pc:spChg>
        <pc:spChg chg="mod">
          <ac:chgData name="Stevens, Meg" userId="02054468-babb-4f50-a3f3-e6523456c3f9" providerId="ADAL" clId="{3116D88C-EB38-43C1-A753-A1A67ECE8C2C}" dt="2025-08-05T15:45:53.256" v="505" actId="20577"/>
          <ac:spMkLst>
            <pc:docMk/>
            <pc:sldMk cId="4038195431" sldId="347"/>
            <ac:spMk id="8" creationId="{C9B36E3D-65EE-BF9A-E05E-EDE0B2B15799}"/>
          </ac:spMkLst>
        </pc:spChg>
      </pc:sldChg>
      <pc:sldChg chg="addSp modSp mod">
        <pc:chgData name="Stevens, Meg" userId="02054468-babb-4f50-a3f3-e6523456c3f9" providerId="ADAL" clId="{3116D88C-EB38-43C1-A753-A1A67ECE8C2C}" dt="2025-08-07T13:59:34.483" v="692" actId="1038"/>
        <pc:sldMkLst>
          <pc:docMk/>
          <pc:sldMk cId="4070941936" sldId="348"/>
        </pc:sldMkLst>
        <pc:spChg chg="add mod">
          <ac:chgData name="Stevens, Meg" userId="02054468-babb-4f50-a3f3-e6523456c3f9" providerId="ADAL" clId="{3116D88C-EB38-43C1-A753-A1A67ECE8C2C}" dt="2025-08-07T13:59:04.697" v="680" actId="20577"/>
          <ac:spMkLst>
            <pc:docMk/>
            <pc:sldMk cId="4070941936" sldId="348"/>
            <ac:spMk id="5" creationId="{85307FE6-FB87-416E-7C87-0D6764DDFB2B}"/>
          </ac:spMkLst>
        </pc:spChg>
        <pc:spChg chg="add mod">
          <ac:chgData name="Stevens, Meg" userId="02054468-babb-4f50-a3f3-e6523456c3f9" providerId="ADAL" clId="{3116D88C-EB38-43C1-A753-A1A67ECE8C2C}" dt="2025-08-07T13:59:13.878" v="681"/>
          <ac:spMkLst>
            <pc:docMk/>
            <pc:sldMk cId="4070941936" sldId="348"/>
            <ac:spMk id="6" creationId="{4494910E-D7BC-7799-BE68-13BFDA8130A6}"/>
          </ac:spMkLst>
        </pc:spChg>
        <pc:spChg chg="mod">
          <ac:chgData name="Stevens, Meg" userId="02054468-babb-4f50-a3f3-e6523456c3f9" providerId="ADAL" clId="{3116D88C-EB38-43C1-A753-A1A67ECE8C2C}" dt="2025-08-07T13:55:50.624" v="559" actId="20577"/>
          <ac:spMkLst>
            <pc:docMk/>
            <pc:sldMk cId="4070941936" sldId="348"/>
            <ac:spMk id="8" creationId="{C9B36E3D-65EE-BF9A-E05E-EDE0B2B15799}"/>
          </ac:spMkLst>
        </pc:spChg>
        <pc:spChg chg="add mod">
          <ac:chgData name="Stevens, Meg" userId="02054468-babb-4f50-a3f3-e6523456c3f9" providerId="ADAL" clId="{3116D88C-EB38-43C1-A753-A1A67ECE8C2C}" dt="2025-08-07T13:59:34.483" v="692" actId="1038"/>
          <ac:spMkLst>
            <pc:docMk/>
            <pc:sldMk cId="4070941936" sldId="348"/>
            <ac:spMk id="12" creationId="{27E6CC63-67E6-1AEC-681C-CC0915515140}"/>
          </ac:spMkLst>
        </pc:spChg>
      </pc:sldChg>
      <pc:sldChg chg="addSp modSp mod">
        <pc:chgData name="Stevens, Meg" userId="02054468-babb-4f50-a3f3-e6523456c3f9" providerId="ADAL" clId="{3116D88C-EB38-43C1-A753-A1A67ECE8C2C}" dt="2025-08-07T14:02:03.025" v="799" actId="20577"/>
        <pc:sldMkLst>
          <pc:docMk/>
          <pc:sldMk cId="4007226033" sldId="349"/>
        </pc:sldMkLst>
        <pc:spChg chg="add mod">
          <ac:chgData name="Stevens, Meg" userId="02054468-babb-4f50-a3f3-e6523456c3f9" providerId="ADAL" clId="{3116D88C-EB38-43C1-A753-A1A67ECE8C2C}" dt="2025-08-07T13:59:29.384" v="688" actId="1038"/>
          <ac:spMkLst>
            <pc:docMk/>
            <pc:sldMk cId="4007226033" sldId="349"/>
            <ac:spMk id="3" creationId="{74391741-2D1D-45B6-FB11-6269971F8272}"/>
          </ac:spMkLst>
        </pc:spChg>
        <pc:spChg chg="mod">
          <ac:chgData name="Stevens, Meg" userId="02054468-babb-4f50-a3f3-e6523456c3f9" providerId="ADAL" clId="{3116D88C-EB38-43C1-A753-A1A67ECE8C2C}" dt="2025-08-07T14:01:39.720" v="776" actId="20577"/>
          <ac:spMkLst>
            <pc:docMk/>
            <pc:sldMk cId="4007226033" sldId="349"/>
            <ac:spMk id="8" creationId="{C9B36E3D-65EE-BF9A-E05E-EDE0B2B15799}"/>
          </ac:spMkLst>
        </pc:spChg>
        <pc:spChg chg="add mod">
          <ac:chgData name="Stevens, Meg" userId="02054468-babb-4f50-a3f3-e6523456c3f9" providerId="ADAL" clId="{3116D88C-EB38-43C1-A753-A1A67ECE8C2C}" dt="2025-08-07T13:59:54.604" v="694"/>
          <ac:spMkLst>
            <pc:docMk/>
            <pc:sldMk cId="4007226033" sldId="349"/>
            <ac:spMk id="12" creationId="{1A2E53A2-AFC7-A23E-132E-82FD65304495}"/>
          </ac:spMkLst>
        </pc:spChg>
        <pc:spChg chg="add mod">
          <ac:chgData name="Stevens, Meg" userId="02054468-babb-4f50-a3f3-e6523456c3f9" providerId="ADAL" clId="{3116D88C-EB38-43C1-A753-A1A67ECE8C2C}" dt="2025-08-07T14:02:03.025" v="799" actId="20577"/>
          <ac:spMkLst>
            <pc:docMk/>
            <pc:sldMk cId="4007226033" sldId="349"/>
            <ac:spMk id="14" creationId="{68F39FDA-768D-74E3-1F13-9C9326346894}"/>
          </ac:spMkLst>
        </pc:spChg>
        <pc:graphicFrameChg chg="add mod">
          <ac:chgData name="Stevens, Meg" userId="02054468-babb-4f50-a3f3-e6523456c3f9" providerId="ADAL" clId="{3116D88C-EB38-43C1-A753-A1A67ECE8C2C}" dt="2025-08-07T13:59:43.289" v="693"/>
          <ac:graphicFrameMkLst>
            <pc:docMk/>
            <pc:sldMk cId="4007226033" sldId="349"/>
            <ac:graphicFrameMk id="6" creationId="{22D89357-ED84-DD2E-FF65-251063AB847E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23E397-8DE7-0DAE-ACC7-AC63449714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EA8EA38-CCBD-9BCE-0B23-AC7598B9C7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5211D2-686D-293D-DBAA-B33698D2E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7CFF1-ECA1-7075-2828-00D81A834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4D26F6-20AC-8D25-C063-D7A4D075F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794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9427A-511C-3962-7048-F2FFAAC0A2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38F284-ECF9-9030-083D-345E011602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612F21-0757-4DD8-C1C3-805696F3A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05F456-3EDA-CE4F-13A4-E1762802C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BD7EAA-A7B5-AF82-CD28-1CA5C8B13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42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106349-C1D8-5425-BE43-9D4FF7A7EF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7EA7F0-F568-7401-C416-EA16BA66BC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4C9265-E838-C969-2879-6BA3544C6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8561A4-0348-B209-DAC8-EBBA3E04B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410DE-31B1-CC5C-4765-EB5BAD471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677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BA99A-FD1F-E837-DC8C-BA44310FC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A44863-A9C3-3C87-9837-F450F50ECE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B699A7-319E-6F1D-6C73-BE78F98BD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AE4F66-4F5C-C524-906A-FFB07B9FC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12192F-A4B9-7B22-88B5-A98FF859A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73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53075-C0C8-38D0-E87F-18552FC41E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ECDDF9-2B0D-D663-EABF-7CFD2E2FAC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4C9B5A-CA12-2D19-93BB-939267678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794712-4BE7-D177-D0BD-6C93BFF4B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92961C-52C0-03DB-979C-04C9C8FEB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975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5D1404-9102-A7DC-0390-46F8AE85AB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4FA9E3-BE5E-BA68-FBE6-48EA9F1212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F6B0EB-83DE-0384-3215-07C81BBCA0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DF29D7-B2DE-7EF4-8D5C-2976F83C7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4FF56C-A00B-8CD2-924D-E09227403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1B15A5-ED40-D824-E097-0E5211217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32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A8C5D-A750-50B0-2A13-D95FAB04DE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3FE800-937B-B8AE-6DDA-163BE1C053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1D0ED5-DD20-488A-3317-01FF1A1CAA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497FD7-5A7A-7799-B44C-F8FD880532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21AD7C-EEC3-8D17-47BB-3AB0228F9E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5B6594-7E4B-569A-E5D8-2F1785857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3C5FD6-3660-4944-50BB-597742348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7756A5-1166-8828-418C-0FA1F0B81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804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0ACFCD-7E3B-E3F4-4DBE-7DA7E64D6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1ECB91-78D3-58B0-D6B9-FD05E98B6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E427A7-7901-E879-51CE-06EE5B1D4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4D2FA4-4DE5-0A8D-CCD6-C5E8C01ED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631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F9B371A-5D50-12AF-4811-13E08B6EF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F65B35-A9E4-C635-A552-514844ADE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B60B84-B757-3589-926C-37B6F1F27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94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530ABD-8868-A206-859B-74A8DD3A74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2EF4D2-8446-3B99-D904-DBDB35E616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AA41FC-D8DB-BBB2-3321-2C29414F71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7DA995-0EFF-D78E-ABE0-25670FB12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98744F-3629-E487-1ED7-DF0449FD8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DB7BFE-7F7E-59B3-9223-07B4BC256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52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795FB-2281-AB69-C955-2DDF6A868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0D4253-CF4C-7CF0-0DA0-35BC63FD96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031B71-8A6F-001D-40FB-59B3467276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B9D11F-3859-9C8F-52A0-75D86DBC0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93566C-4637-7FE2-8BE7-1C138DDDE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304BF4-1E0E-E95B-581B-BC2BC6969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324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B14B5C-FA69-6F42-0838-641F6BFF94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0967D2-C35F-86B4-C000-09BE654394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798EC-0FDB-E55B-759C-101CD599BF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2660C3-40D5-D34D-BF16-95628233BB7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9F8407-6D9B-8D08-8BEF-6968FB83CE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8F4BF5-4DDA-6281-118C-D8911075BB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FE612-0882-D042-9D02-51FFCB4370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013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emf"/><Relationship Id="rId4" Type="http://schemas.openxmlformats.org/officeDocument/2006/relationships/oleObject" Target="../embeddings/oleObject11.bin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emf"/><Relationship Id="rId4" Type="http://schemas.openxmlformats.org/officeDocument/2006/relationships/oleObject" Target="../embeddings/oleObject12.bin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emf"/><Relationship Id="rId4" Type="http://schemas.openxmlformats.org/officeDocument/2006/relationships/oleObject" Target="../embeddings/oleObject1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emf"/><Relationship Id="rId4" Type="http://schemas.openxmlformats.org/officeDocument/2006/relationships/oleObject" Target="../embeddings/oleObject6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emf"/><Relationship Id="rId4" Type="http://schemas.openxmlformats.org/officeDocument/2006/relationships/oleObject" Target="../embeddings/oleObject8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0B013FC-FFBE-5D8E-FBBD-CB30A14839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3472" y="1194050"/>
            <a:ext cx="4853412" cy="2234950"/>
          </a:xfrm>
          <a:prstGeom prst="rect">
            <a:avLst/>
          </a:prstGeom>
        </p:spPr>
      </p:pic>
      <p:sp>
        <p:nvSpPr>
          <p:cNvPr id="5" name="Rectangle 2">
            <a:extLst>
              <a:ext uri="{FF2B5EF4-FFF2-40B4-BE49-F238E27FC236}">
                <a16:creationId xmlns:a16="http://schemas.microsoft.com/office/drawing/2014/main" id="{20CA3CFD-978C-148C-FF23-6FD45C84E4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5200" y="60157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F7D02B-C4D0-6F77-56CF-B828A02ECF15}"/>
              </a:ext>
            </a:extLst>
          </p:cNvPr>
          <p:cNvSpPr txBox="1"/>
          <p:nvPr/>
        </p:nvSpPr>
        <p:spPr>
          <a:xfrm>
            <a:off x="782052" y="4740620"/>
            <a:ext cx="1062789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scillating high glucose significantly increases the BCL-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X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/BCL-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X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 ratio. </a:t>
            </a:r>
          </a:p>
          <a:p>
            <a:pPr algn="just"/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T-PCR samples from HEK293 cells treated with normal glucose (5.5 mM)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mannitol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oscillating 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nitol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high 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ucose (25 mM)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r oscillating high glucose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H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for 48 h were run on the bioanalyzer. Oscillating treatment involves changing media from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o either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G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ack and forth every 12 h till 48 h is reached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Bioanalyzer gel image.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antification of the BCL-XS/BCL-XL ratio showed a significant increase between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H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***p &lt; 0.0001, 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= 4-6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r>
              <a:rPr lang="en-US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d between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HG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**p = 0.0005, 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= 4-6</a:t>
            </a:r>
            <a:r>
              <a:rPr lang="en-US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en-GB" sz="1200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ere analysed using an ordinary one-way ANOVA (overall ****p &lt; 0.0001) with a multiple comparison post hoc analysis.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GB" sz="1200" dirty="0">
              <a:solidFill>
                <a:srgbClr val="0D0D0D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138CFAA-7A2B-B957-0620-215B68FA6384}"/>
              </a:ext>
            </a:extLst>
          </p:cNvPr>
          <p:cNvSpPr txBox="1"/>
          <p:nvPr/>
        </p:nvSpPr>
        <p:spPr>
          <a:xfrm>
            <a:off x="973472" y="7820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6981DB-EE08-3AA4-680F-4386B19F3597}"/>
              </a:ext>
            </a:extLst>
          </p:cNvPr>
          <p:cNvSpPr txBox="1"/>
          <p:nvPr/>
        </p:nvSpPr>
        <p:spPr>
          <a:xfrm>
            <a:off x="6772693" y="774396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9F59DE9-E9AD-5792-7A75-98DA91D8FA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9723312"/>
              </p:ext>
            </p:extLst>
          </p:nvPr>
        </p:nvGraphicFramePr>
        <p:xfrm>
          <a:off x="7361763" y="460355"/>
          <a:ext cx="3378302" cy="40424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801891" imgH="3352621" progId="Prism10.Document">
                  <p:embed/>
                </p:oleObj>
              </mc:Choice>
              <mc:Fallback>
                <p:oleObj name="Prism 10" r:id="rId3" imgW="2801891" imgH="335262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9F59DE9-E9AD-5792-7A75-98DA91D8FA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361763" y="460355"/>
                        <a:ext cx="3378302" cy="40424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097084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006579"/>
            <a:ext cx="1062789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0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Gender has no significant influence on the BCL-XS/BCL-XL expression ratio obtained from urine sediment sampl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NA was obtained from RNA extracted from sediments of urine collected from patients overnight. RT-PCR was performed using BCL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calculate the BCL-XS/BCL-XL ratio. The BCL-XS/BCL-XL expression ratio was plotted based on patient’s gender. The data was statisticall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y a Mann-Whitney test (ns p = 0.747; n = 14-15 patients). 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Gender has no significant influence on the BCL-XS/BCL-XL expression ratio obtained from leukocyt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NA was obtained from RNA extracted from leucocytes. RTPCR was performed using BCL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calculate the BCL-XS/BCL-XL ratio. The BCL-XS/BCL-XL expression ratio was plotted based on patient’s gender. The data was statisticall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y a Mann-Whitney test  (ns p = 0.453; n = 15-30 patients)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973472" y="7820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6096000" y="840818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275E3C63-25BE-05B8-33AA-D8AF863E6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831" y="9384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4">
            <a:extLst>
              <a:ext uri="{FF2B5EF4-FFF2-40B4-BE49-F238E27FC236}">
                <a16:creationId xmlns:a16="http://schemas.microsoft.com/office/drawing/2014/main" id="{CD407350-9602-BF5E-3FDB-F818E1421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377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BAF5A66-B6AC-AFE9-4058-639C31A697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9578" y="103610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8" name="Rectangle 4">
            <a:extLst>
              <a:ext uri="{FF2B5EF4-FFF2-40B4-BE49-F238E27FC236}">
                <a16:creationId xmlns:a16="http://schemas.microsoft.com/office/drawing/2014/main" id="{7E483F17-FABD-83C4-453E-664DF605CE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4601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0DB724E8-925C-1243-A018-197101A6F8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4111239"/>
              </p:ext>
            </p:extLst>
          </p:nvPr>
        </p:nvGraphicFramePr>
        <p:xfrm>
          <a:off x="1375458" y="727764"/>
          <a:ext cx="2930739" cy="31535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276424" imgH="2449037" progId="Prism10.Document">
                  <p:embed/>
                </p:oleObj>
              </mc:Choice>
              <mc:Fallback>
                <p:oleObj name="Prism 10" r:id="rId2" imgW="2276424" imgH="2449037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0DB724E8-925C-1243-A018-197101A6F8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75458" y="727764"/>
                        <a:ext cx="2930739" cy="31535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11A20C35-8589-15EF-2F76-53907CB607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2481977"/>
              </p:ext>
            </p:extLst>
          </p:nvPr>
        </p:nvGraphicFramePr>
        <p:xfrm>
          <a:off x="6653250" y="723289"/>
          <a:ext cx="3032201" cy="32832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262747" imgH="2449037" progId="Prism10.Document">
                  <p:embed/>
                </p:oleObj>
              </mc:Choice>
              <mc:Fallback>
                <p:oleObj name="Prism 10" r:id="rId4" imgW="2262747" imgH="2449037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11A20C35-8589-15EF-2F76-53907CB607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653250" y="723289"/>
                        <a:ext cx="3032201" cy="32832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9774174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006579"/>
            <a:ext cx="1062789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1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i. IL-6 increases the mRNA expression of the pro-apoptotic BCL-XS isoform in a concentration-dependent manner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K293 cells were treated with or without recombinant human IL-6 at varying concentrations (0, 0.1, 1, 10, 25, or 50 ng/ml). RNA was extracted after 48 h followed by RT-PCR for BCL-X isoforms.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ii. IL-6 increases the mRNA BCL-XS/BCL-XL ratio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nds from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i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analyzed by densitometry using ImageJ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IL-6 increases apoptosis in a dose-wise manner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K293 cells were treated with or without recombinant human IL-6 at varying concentrations (0, 0.1, 1, 10, 25, or 50 ng/ml). A JC-10 assay was performed after 24 h of treatment to measure mitochondrial membrane depolarization as a marker of apoptosis. IL-6 at 1 ng/ml (*p = 0.028, n = 18 repeats), 10 ng/ml (***p = 0.0009, n = 16 repeats), 25 ng/ml (**p = 0.007, n = 15 repeats), and 50 ng/ml (****p &lt; 0.0001, n = 18 repeats) showed a significant increase in apoptosis relative to 0 ng/ml. Data were statisticall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sing the Kruskal-Wallis test (overall ****p &lt; 0.0001) and a multiple comparison post-hoc analysis.</a:t>
            </a:r>
          </a:p>
          <a:p>
            <a:pPr marL="228600" indent="-228600" algn="just">
              <a:buAutoNum type="alphaUcPeriod"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4589671" y="75379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ii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275E3C63-25BE-05B8-33AA-D8AF863E6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831" y="9384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4">
            <a:extLst>
              <a:ext uri="{FF2B5EF4-FFF2-40B4-BE49-F238E27FC236}">
                <a16:creationId xmlns:a16="http://schemas.microsoft.com/office/drawing/2014/main" id="{CD407350-9602-BF5E-3FDB-F818E1421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377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BAF5A66-B6AC-AFE9-4058-639C31A697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9578" y="103610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8" name="Rectangle 4">
            <a:extLst>
              <a:ext uri="{FF2B5EF4-FFF2-40B4-BE49-F238E27FC236}">
                <a16:creationId xmlns:a16="http://schemas.microsoft.com/office/drawing/2014/main" id="{7E483F17-FABD-83C4-453E-664DF605CE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4601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2" name="Rectangle 2">
            <a:extLst>
              <a:ext uri="{FF2B5EF4-FFF2-40B4-BE49-F238E27FC236}">
                <a16:creationId xmlns:a16="http://schemas.microsoft.com/office/drawing/2014/main" id="{8EA54945-96D1-86F6-2212-80589EB9FA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5654" y="550111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4019CE-31BF-0C72-D085-ED08B2D4FCA5}"/>
              </a:ext>
            </a:extLst>
          </p:cNvPr>
          <p:cNvSpPr txBox="1"/>
          <p:nvPr/>
        </p:nvSpPr>
        <p:spPr>
          <a:xfrm>
            <a:off x="5310869" y="-7070"/>
            <a:ext cx="979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HEK-293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50FA5357-CFD3-6854-DA3A-C90CE8DA51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09556" y="838019"/>
            <a:ext cx="2953387" cy="309131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03ECBB58-7B3F-DC7E-27CA-B33E193A84F9}"/>
              </a:ext>
            </a:extLst>
          </p:cNvPr>
          <p:cNvSpPr txBox="1"/>
          <p:nvPr/>
        </p:nvSpPr>
        <p:spPr>
          <a:xfrm>
            <a:off x="8513860" y="7185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0529" y="831886"/>
            <a:ext cx="3952028" cy="2619187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56084" y="753797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i. 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249F2C8E-FCA4-D7D8-C692-85007DA537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5708412"/>
              </p:ext>
            </p:extLst>
          </p:nvPr>
        </p:nvGraphicFramePr>
        <p:xfrm>
          <a:off x="8614397" y="-7070"/>
          <a:ext cx="3403201" cy="43530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986164" imgH="3819173" progId="Prism10.Document">
                  <p:embed/>
                </p:oleObj>
              </mc:Choice>
              <mc:Fallback>
                <p:oleObj name="Prism 10" r:id="rId4" imgW="2986164" imgH="3819173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249F2C8E-FCA4-D7D8-C692-85007DA537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614397" y="-7070"/>
                        <a:ext cx="3403201" cy="43530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9439812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006579"/>
            <a:ext cx="106278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2. SF3B1 expression is not regulated by IL-6 i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EnC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EnC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ere treated for 6 h (A) and 24 h (B) with 0, 1, or 25 ng/ml IL-6. There was no significant change in the mRNA expression of SF3B1 after either 6 or 24 h in response to IL-6 treatment (n = 3-6; p = ns as assessed by Kruskal-Wallis)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973472" y="7820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7014829" y="85144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275E3C63-25BE-05B8-33AA-D8AF863E6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831" y="9384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4">
            <a:extLst>
              <a:ext uri="{FF2B5EF4-FFF2-40B4-BE49-F238E27FC236}">
                <a16:creationId xmlns:a16="http://schemas.microsoft.com/office/drawing/2014/main" id="{CD407350-9602-BF5E-3FDB-F818E1421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377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BAF5A66-B6AC-AFE9-4058-639C31A697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9578" y="103610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8" name="Rectangle 4">
            <a:extLst>
              <a:ext uri="{FF2B5EF4-FFF2-40B4-BE49-F238E27FC236}">
                <a16:creationId xmlns:a16="http://schemas.microsoft.com/office/drawing/2014/main" id="{7E483F17-FABD-83C4-453E-664DF605CE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4601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2" name="Rectangle 2">
            <a:extLst>
              <a:ext uri="{FF2B5EF4-FFF2-40B4-BE49-F238E27FC236}">
                <a16:creationId xmlns:a16="http://schemas.microsoft.com/office/drawing/2014/main" id="{8EA54945-96D1-86F6-2212-80589EB9FA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35654" y="550111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A6F8EB9A-4CB6-52D2-0F25-469ABB16CE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2021666"/>
              </p:ext>
            </p:extLst>
          </p:nvPr>
        </p:nvGraphicFramePr>
        <p:xfrm>
          <a:off x="1571873" y="938463"/>
          <a:ext cx="3571875" cy="2744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571376" imgH="2744592" progId="Prism10.Document">
                  <p:embed/>
                </p:oleObj>
              </mc:Choice>
              <mc:Fallback>
                <p:oleObj name="Prism 10" r:id="rId2" imgW="3571376" imgH="2744592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A6F8EB9A-4CB6-52D2-0F25-469ABB16CE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71873" y="938463"/>
                        <a:ext cx="3571875" cy="2744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2F206CB8-DA77-54FD-F4FF-CE465C1765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6425161"/>
              </p:ext>
            </p:extLst>
          </p:nvPr>
        </p:nvGraphicFramePr>
        <p:xfrm>
          <a:off x="7431505" y="938462"/>
          <a:ext cx="3571875" cy="2744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571376" imgH="2744592" progId="Prism10.Document">
                  <p:embed/>
                </p:oleObj>
              </mc:Choice>
              <mc:Fallback>
                <p:oleObj name="Prism 10" r:id="rId4" imgW="3571376" imgH="2744592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2F206CB8-DA77-54FD-F4FF-CE465C1765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431505" y="938462"/>
                        <a:ext cx="3571875" cy="2744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60D2D08-E284-1DCE-DB13-2AB51BCB9FC2}"/>
              </a:ext>
            </a:extLst>
          </p:cNvPr>
          <p:cNvCxnSpPr>
            <a:cxnSpLocks/>
          </p:cNvCxnSpPr>
          <p:nvPr/>
        </p:nvCxnSpPr>
        <p:spPr>
          <a:xfrm>
            <a:off x="2781596" y="1122142"/>
            <a:ext cx="1481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1A8962F5-0425-AF79-6891-E25912795FDF}"/>
              </a:ext>
            </a:extLst>
          </p:cNvPr>
          <p:cNvSpPr txBox="1"/>
          <p:nvPr/>
        </p:nvSpPr>
        <p:spPr>
          <a:xfrm>
            <a:off x="3360981" y="855413"/>
            <a:ext cx="3231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ns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61BE2684-9FAA-C1F8-FCA9-139CEB8FCE32}"/>
              </a:ext>
            </a:extLst>
          </p:cNvPr>
          <p:cNvCxnSpPr>
            <a:cxnSpLocks/>
          </p:cNvCxnSpPr>
          <p:nvPr/>
        </p:nvCxnSpPr>
        <p:spPr>
          <a:xfrm>
            <a:off x="8624477" y="1144667"/>
            <a:ext cx="1481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3F187B45-D9DB-886F-1533-0BC8706C150F}"/>
              </a:ext>
            </a:extLst>
          </p:cNvPr>
          <p:cNvSpPr txBox="1"/>
          <p:nvPr/>
        </p:nvSpPr>
        <p:spPr>
          <a:xfrm>
            <a:off x="9203862" y="877938"/>
            <a:ext cx="3231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3219659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6A8F55EF-5B90-B0B2-6733-F23871CE41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1526" y="43313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FE47FD-4B0B-E066-E64D-5CC0F8670B7C}"/>
              </a:ext>
            </a:extLst>
          </p:cNvPr>
          <p:cNvSpPr txBox="1"/>
          <p:nvPr/>
        </p:nvSpPr>
        <p:spPr>
          <a:xfrm>
            <a:off x="782052" y="5039868"/>
            <a:ext cx="106278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GB" sz="1200" b="1" dirty="0">
                <a:solidFill>
                  <a:srgbClr val="0D0D0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scillating high glucos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treatment increases apoptosis in HEK293 cells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K293 cells were treated with 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glucose (5.5 mM) 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mannitol 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oscillating mannitol 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high glucose (25 mM) 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G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 oscillating high glucose </a:t>
            </a:r>
            <a:r>
              <a:rPr lang="en-GB" sz="1200" b="1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HG</a:t>
            </a:r>
            <a:r>
              <a:rPr lang="en-GB" sz="1200" dirty="0">
                <a:solidFill>
                  <a:srgbClr val="0D0D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or 48 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A JC-10 assay was then performed to assess mitochondrial depolarization as a marker of apoptosis. The graph shows the relative level of apoptotic cells. Statistical analysis was performed using an ordinary one-way ANOVA (overall ***p &lt; 0.001). A statistically significant increase in apoptosis is observed for the pairwise analysis between NG and OHG (*p = 0.031, n = 10), HG and OHG (**p = 0.0037, n = 10) and OM and OHG (**p = 0.0047, n = 10). 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5859CD4-B7A1-4FAA-0B1F-7765371877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2704735"/>
              </p:ext>
            </p:extLst>
          </p:nvPr>
        </p:nvGraphicFramePr>
        <p:xfrm>
          <a:off x="3917568" y="725218"/>
          <a:ext cx="3936236" cy="42571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95937" imgH="3348301" progId="Prism10.Document">
                  <p:embed/>
                </p:oleObj>
              </mc:Choice>
              <mc:Fallback>
                <p:oleObj name="Prism 10" r:id="rId2" imgW="3095937" imgH="334830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5859CD4-B7A1-4FAA-0B1F-7765371877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17568" y="725218"/>
                        <a:ext cx="3936236" cy="42571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755095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>
            <a:extLst>
              <a:ext uri="{FF2B5EF4-FFF2-40B4-BE49-F238E27FC236}">
                <a16:creationId xmlns:a16="http://schemas.microsoft.com/office/drawing/2014/main" id="{20CA3CFD-978C-148C-FF23-6FD45C84E4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5200" y="60157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F7D02B-C4D0-6F77-56CF-B828A02ECF15}"/>
              </a:ext>
            </a:extLst>
          </p:cNvPr>
          <p:cNvSpPr txBox="1"/>
          <p:nvPr/>
        </p:nvSpPr>
        <p:spPr>
          <a:xfrm>
            <a:off x="782052" y="4740620"/>
            <a:ext cx="106278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Glucose soup, but not oscillating glucose soup, significantly increases the BCL-XS/BCL-XL ratio.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T-PCR samples from HEK293 cells treated with normal glucose (5.5 mM)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mannitol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oscillating mannitol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glucose soup (25 mM with TNF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 1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g/ml, IL-6 1 ng/ml, and insulin 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S+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 oscillating glucose soup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GS+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r 48 h were run on the bioanalyzer. Oscillating treatment involves changing media from NG to either M or GS+ back and forth every 12 h till 48 h is reache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Bioanalyzer gel image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Quantification of the BCL-XS/BCL-XL ratio shows a significant increase between NG and GS+ (*p = 0.025, n = 4) and between M and GS+ (*p = 0.027, n = 4). Data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sing an ordinary one-way ANOVA (overall *p &lt; 0.05) with a multiple comparison post hoc analysis.  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138CFAA-7A2B-B957-0620-215B68FA6384}"/>
              </a:ext>
            </a:extLst>
          </p:cNvPr>
          <p:cNvSpPr txBox="1"/>
          <p:nvPr/>
        </p:nvSpPr>
        <p:spPr>
          <a:xfrm>
            <a:off x="973472" y="78205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6981DB-EE08-3AA4-680F-4386B19F3597}"/>
              </a:ext>
            </a:extLst>
          </p:cNvPr>
          <p:cNvSpPr txBox="1"/>
          <p:nvPr/>
        </p:nvSpPr>
        <p:spPr>
          <a:xfrm>
            <a:off x="6772693" y="774396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498A395-3CF3-69FB-FE83-0F9E522B12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4274" y="78205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16" name="Group 15"/>
          <p:cNvGrpSpPr/>
          <p:nvPr/>
        </p:nvGrpSpPr>
        <p:grpSpPr>
          <a:xfrm>
            <a:off x="973472" y="1151385"/>
            <a:ext cx="4895065" cy="2277615"/>
            <a:chOff x="973472" y="1337510"/>
            <a:chExt cx="4683125" cy="22098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E2CCE79-862E-B362-00BC-8722B0AE80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3472" y="1337510"/>
              <a:ext cx="4683125" cy="2209800"/>
            </a:xfrm>
            <a:prstGeom prst="rect">
              <a:avLst/>
            </a:prstGeom>
            <a:noFill/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37" t="49970" r="465" b="14663"/>
            <a:stretch/>
          </p:blipFill>
          <p:spPr>
            <a:xfrm>
              <a:off x="2876550" y="2311400"/>
              <a:ext cx="2657475" cy="1171574"/>
            </a:xfrm>
            <a:prstGeom prst="rect">
              <a:avLst/>
            </a:prstGeom>
          </p:spPr>
        </p:pic>
      </p:grp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4E391C6-A137-DE74-9967-36132DF4F0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2561701"/>
              </p:ext>
            </p:extLst>
          </p:nvPr>
        </p:nvGraphicFramePr>
        <p:xfrm>
          <a:off x="7315200" y="547720"/>
          <a:ext cx="3493639" cy="41428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801891" imgH="3322382" progId="Prism10.Document">
                  <p:embed/>
                </p:oleObj>
              </mc:Choice>
              <mc:Fallback>
                <p:oleObj name="Prism 10" r:id="rId4" imgW="2801891" imgH="3322382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4E391C6-A137-DE74-9967-36132DF4F0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315200" y="547720"/>
                        <a:ext cx="3493639" cy="41428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158737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6A8F55EF-5B90-B0B2-6733-F23871CE41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1526" y="43313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FE47FD-4B0B-E066-E64D-5CC0F8670B7C}"/>
              </a:ext>
            </a:extLst>
          </p:cNvPr>
          <p:cNvSpPr txBox="1"/>
          <p:nvPr/>
        </p:nvSpPr>
        <p:spPr>
          <a:xfrm>
            <a:off x="782052" y="4740620"/>
            <a:ext cx="1062789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Glucose soup, but not oscillating glucose soup, increased apoptosis in HEK293 cells.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K293 cells were treated with normal glucose (5.5 mM)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mannitol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oscillating mannitol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glucose soup (25 mM with TNF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 1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g/ml, IL-6 1 ng/ml, and insulin 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S+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 oscillating glucose soup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GS+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r 48 h. A JC-10 assay was then performed to assess mitochondrial depolarization as a marker of apoptosis. The graph shows the relative level of apoptotic cells. Statistical analysis was performed using an ordinary one-way ANOVA. A statistically significant increase in apoptosis was seen in the pairwise analysis between NG and GS+ (****p &lt; 0.0001, n = 16-18), M and GS+ (****p &lt; 0.0001, n = 16-18), and between GS+ and OGS+ (**p = 0.005, n = 16-18).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B816FF81-9E6F-088C-4E1B-792178FC94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6515" y="154895"/>
            <a:ext cx="15417848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773E75D-CEFF-3B65-168D-DA00C87D3A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3603331"/>
              </p:ext>
            </p:extLst>
          </p:nvPr>
        </p:nvGraphicFramePr>
        <p:xfrm>
          <a:off x="4102428" y="408776"/>
          <a:ext cx="3574741" cy="42210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977167" imgH="3514258" progId="Prism10.Document">
                  <p:embed/>
                </p:oleObj>
              </mc:Choice>
              <mc:Fallback>
                <p:oleObj name="Prism 10" r:id="rId2" imgW="2977167" imgH="3514258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773E75D-CEFF-3B65-168D-DA00C87D3A2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02428" y="408776"/>
                        <a:ext cx="3574741" cy="42210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577802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F03E603E-AE8F-655E-0534-7552E7B4A3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0993" y="228600"/>
            <a:ext cx="5450866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                                  24 hours                             48 hours </a:t>
            </a:r>
            <a:endParaRPr kumimoji="0" lang="en-GB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25" name="Picture 1">
            <a:extLst>
              <a:ext uri="{FF2B5EF4-FFF2-40B4-BE49-F238E27FC236}">
                <a16:creationId xmlns:a16="http://schemas.microsoft.com/office/drawing/2014/main" id="{EBA33C3A-0F71-F75C-8B27-E741D8BB6E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0217" y="505599"/>
            <a:ext cx="5502599" cy="4905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1BFEE1D3-680B-7645-FF54-E79D2984A0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2540" y="5616721"/>
            <a:ext cx="9144000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</a:t>
            </a:r>
            <a:r>
              <a:rPr lang="en-GB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ransient transfection of HEK293 cells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Cells were transfected with a </a:t>
            </a:r>
            <a:r>
              <a:rPr kumimoji="0" lang="en-GB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cl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XL overexpression plasmid </a:t>
            </a:r>
            <a:r>
              <a:rPr lang="en-GB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pressing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GFP using </a:t>
            </a:r>
            <a:r>
              <a:rPr kumimoji="0" lang="en-GB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rbofectin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ransfection kit for 48 h. Images taken with EVOS-FL 10X magnification.</a:t>
            </a:r>
            <a:endParaRPr kumimoji="0" lang="en-GB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55268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2CA281A-A763-D41B-0E77-32A007F23563}"/>
              </a:ext>
            </a:extLst>
          </p:cNvPr>
          <p:cNvGrpSpPr/>
          <p:nvPr/>
        </p:nvGrpSpPr>
        <p:grpSpPr>
          <a:xfrm>
            <a:off x="2320714" y="1888846"/>
            <a:ext cx="7550572" cy="995558"/>
            <a:chOff x="2423592" y="4078593"/>
            <a:chExt cx="7550572" cy="995558"/>
          </a:xfrm>
        </p:grpSpPr>
        <p:sp>
          <p:nvSpPr>
            <p:cNvPr id="8" name="TextBox 29">
              <a:extLst>
                <a:ext uri="{FF2B5EF4-FFF2-40B4-BE49-F238E27FC236}">
                  <a16:creationId xmlns:a16="http://schemas.microsoft.com/office/drawing/2014/main" id="{0BB775A6-5AE3-8714-FAC3-8EF3AF83BB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688289" y="4257635"/>
              <a:ext cx="12858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7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684213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3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39825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9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597025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2638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098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670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42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14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CL-XL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29">
              <a:extLst>
                <a:ext uri="{FF2B5EF4-FFF2-40B4-BE49-F238E27FC236}">
                  <a16:creationId xmlns:a16="http://schemas.microsoft.com/office/drawing/2014/main" id="{E626DD58-2C35-9942-71A9-0349661379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688289" y="4653137"/>
              <a:ext cx="12858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7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684213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3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39825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9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597025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2638" indent="-227013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098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670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42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1438" indent="-227013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17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CL-XS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Picture 2" descr="A screenshot of a computer&#10;&#10;Description automatically generated with low confidence">
              <a:extLst>
                <a:ext uri="{FF2B5EF4-FFF2-40B4-BE49-F238E27FC236}">
                  <a16:creationId xmlns:a16="http://schemas.microsoft.com/office/drawing/2014/main" id="{F11E91F0-BBB9-5949-ED85-75F13E99996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23592" y="4078593"/>
              <a:ext cx="6126511" cy="995558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CF63D90-111D-F1B1-EA55-80C5AF913FA5}"/>
              </a:ext>
            </a:extLst>
          </p:cNvPr>
          <p:cNvSpPr txBox="1"/>
          <p:nvPr/>
        </p:nvSpPr>
        <p:spPr>
          <a:xfrm>
            <a:off x="697831" y="3543618"/>
            <a:ext cx="106278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Example RT-PCR analysis of BCL-X splice isoforms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in individual patient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rine samples.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NA was isolated from the urinary sediment and RT-PCR with specific primers for the two BCL-X splice isoforms was performed. </a:t>
            </a: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176703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499811"/>
            <a:ext cx="1062789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. </a:t>
            </a: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BCL-XS/BCL-XL ratio from urine sediment does not correlate with serum creatinine level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NA was obtained from RNA extracted from sediments of urine collected from patients overnight. RT-PCR was performed using BCL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calculate the BCL-XS/BCL-XL ratio. A graph of the serum creatinine against the urinary sediment BCL-XS/BCL-XL ratio was generated using GraphPad prism. The data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Pearson correlation analysis followed by linear regression analysis (r = 0.257, ns p = 0.188, n = 28 overnight urine samples)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CL-XS/BCL-XL ratio in leucocytes showed no correlation with serum creatinine level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DNA was obtained from RNA extracted from leucocytes. RTPCR was performed using BCL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calculate the BCL-XS/BCL-XL ratio. A graph of serum creatinine against the leucocyte BCL-XS/BCL-XL ratio was generated using GraphPad prism. Pearson correlation analysis was performed followed by linear regression analysis. (r = 0.010, ns p = 0.948, n = 43 blood samples). Log transformation was used to transform the data before Pearson correlation was applied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113663" y="11302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6121510" y="63142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9218654"/>
              </p:ext>
            </p:extLst>
          </p:nvPr>
        </p:nvGraphicFramePr>
        <p:xfrm>
          <a:off x="6987295" y="-36221"/>
          <a:ext cx="3783013" cy="2700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782505" imgH="2700075" progId="Prism10.Document">
                  <p:embed/>
                </p:oleObj>
              </mc:Choice>
              <mc:Fallback>
                <p:oleObj name="Prism 10" r:id="rId2" imgW="3782505" imgH="2700075" progId="Prism10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87295" y="-36221"/>
                        <a:ext cx="3783013" cy="2700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4809638"/>
              </p:ext>
            </p:extLst>
          </p:nvPr>
        </p:nvGraphicFramePr>
        <p:xfrm>
          <a:off x="881397" y="-44728"/>
          <a:ext cx="3770313" cy="2700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770261" imgH="2700075" progId="Prism10.Document">
                  <p:embed/>
                </p:oleObj>
              </mc:Choice>
              <mc:Fallback>
                <p:oleObj name="Prism 10" r:id="rId4" imgW="3770261" imgH="2700075" progId="Prism10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81397" y="-44728"/>
                        <a:ext cx="3770313" cy="2700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308E0817-F896-D14C-23AA-4CF9EEB599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2474788"/>
              </p:ext>
            </p:extLst>
          </p:nvPr>
        </p:nvGraphicFramePr>
        <p:xfrm>
          <a:off x="1487488" y="2676260"/>
          <a:ext cx="3276600" cy="1781175"/>
        </p:xfrm>
        <a:graphic>
          <a:graphicData uri="http://schemas.openxmlformats.org/drawingml/2006/table">
            <a:tbl>
              <a:tblPr/>
              <a:tblGrid>
                <a:gridCol w="2031492">
                  <a:extLst>
                    <a:ext uri="{9D8B030D-6E8A-4147-A177-3AD203B41FA5}">
                      <a16:colId xmlns:a16="http://schemas.microsoft.com/office/drawing/2014/main" val="3751838134"/>
                    </a:ext>
                  </a:extLst>
                </a:gridCol>
                <a:gridCol w="1245108">
                  <a:extLst>
                    <a:ext uri="{9D8B030D-6E8A-4147-A177-3AD203B41FA5}">
                      <a16:colId xmlns:a16="http://schemas.microsoft.com/office/drawing/2014/main" val="2517000766"/>
                    </a:ext>
                  </a:extLst>
                </a:gridCol>
              </a:tblGrid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4829990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25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4647966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1288 to 0.57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9638617"/>
                  </a:ext>
                </a:extLst>
              </a:tr>
              <a:tr h="5164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65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8354611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757337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0889486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18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9463064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5498600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7174112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841691"/>
                  </a:ext>
                </a:extLst>
              </a:tr>
              <a:tr h="6371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7821285"/>
                  </a:ext>
                </a:extLst>
              </a:tr>
            </a:tbl>
          </a:graphicData>
        </a:graphic>
      </p:graphicFrame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7835719"/>
              </p:ext>
            </p:extLst>
          </p:nvPr>
        </p:nvGraphicFramePr>
        <p:xfrm>
          <a:off x="7608888" y="2691376"/>
          <a:ext cx="3276600" cy="1781175"/>
        </p:xfrm>
        <a:graphic>
          <a:graphicData uri="http://schemas.openxmlformats.org/drawingml/2006/table">
            <a:tbl>
              <a:tblPr/>
              <a:tblGrid>
                <a:gridCol w="18945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820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010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3096 to 0.29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0010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94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9234E80-6F0C-675A-8B74-0862F5A7C25B}"/>
              </a:ext>
            </a:extLst>
          </p:cNvPr>
          <p:cNvSpPr txBox="1"/>
          <p:nvPr/>
        </p:nvSpPr>
        <p:spPr>
          <a:xfrm rot="16200000">
            <a:off x="17025" y="985787"/>
            <a:ext cx="21222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Urine BCL-XS/BCL-X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A1502A-4D4B-A906-44B2-5B197059F95A}"/>
              </a:ext>
            </a:extLst>
          </p:cNvPr>
          <p:cNvSpPr txBox="1"/>
          <p:nvPr/>
        </p:nvSpPr>
        <p:spPr>
          <a:xfrm rot="16200000">
            <a:off x="5962295" y="1031010"/>
            <a:ext cx="237802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Leukocyte BCL-XS/BCL-X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6763F94-2704-ABAE-F374-0B431B6D4D01}"/>
              </a:ext>
            </a:extLst>
          </p:cNvPr>
          <p:cNvSpPr txBox="1"/>
          <p:nvPr/>
        </p:nvSpPr>
        <p:spPr>
          <a:xfrm>
            <a:off x="1872616" y="2356885"/>
            <a:ext cx="21222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erum Creatinine (µmol/L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5E4846-75B3-4FF6-CCAD-18814C234D5B}"/>
              </a:ext>
            </a:extLst>
          </p:cNvPr>
          <p:cNvSpPr txBox="1"/>
          <p:nvPr/>
        </p:nvSpPr>
        <p:spPr>
          <a:xfrm>
            <a:off x="8003300" y="2378610"/>
            <a:ext cx="21222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erum Creatinine (µmol/L)</a:t>
            </a:r>
          </a:p>
        </p:txBody>
      </p:sp>
    </p:spTree>
    <p:extLst>
      <p:ext uri="{BB962C8B-B14F-4D97-AF65-F5344CB8AC3E}">
        <p14:creationId xmlns:p14="http://schemas.microsoft.com/office/powerpoint/2010/main" val="40381954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8084" y="105728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499811"/>
            <a:ext cx="1062789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BCL-XS/BCL-XL ratio from urine sediment does not correlate with glycate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aemoglobi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NA was obtained from RNA extracted from sediments of urine collected from patients overnight. RT-PCR was performed using BCL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calculate the BCL-XS/BCL-XL ratio. A graph of HbA1c against the urinary sediment BCL-XS/BCL-XL ratio was generated using GraphPad prism. Pearson correlation analysis and a linear regression analysis were performed (r = 0.065, ns p = 0.74, n = 28 overnight urine samples)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CL-XS/BCL-XL ratio in leucocytes showed no correlation with glycate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aemoglobi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NA was obtained from RNA extracted from leucocytes. RTPCR was performed using BCL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calculate the BCL-XS/BCL-XL ratio. A graph of HbA1c against the leucocyte BCL-XS/BCL-XL ratio was generated using GraphPad prism. Data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sing Pearson correlation analysis and linear regression (r = -0.115, ns p = 0.464, n = 43 blood samples)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79911" y="11331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6096000" y="11331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024130"/>
              </p:ext>
            </p:extLst>
          </p:nvPr>
        </p:nvGraphicFramePr>
        <p:xfrm>
          <a:off x="7010304" y="-49948"/>
          <a:ext cx="3773487" cy="2700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773502" imgH="2700075" progId="Prism10.Document">
                  <p:embed/>
                </p:oleObj>
              </mc:Choice>
              <mc:Fallback>
                <p:oleObj name="Prism 10" r:id="rId2" imgW="3773502" imgH="2700075" progId="Prism10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10304" y="-49948"/>
                        <a:ext cx="3773487" cy="2700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7476571"/>
              </p:ext>
            </p:extLst>
          </p:nvPr>
        </p:nvGraphicFramePr>
        <p:xfrm>
          <a:off x="897683" y="-55335"/>
          <a:ext cx="3770313" cy="2695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770261" imgH="2695753" progId="Prism10.Document">
                  <p:embed/>
                </p:oleObj>
              </mc:Choice>
              <mc:Fallback>
                <p:oleObj name="Prism 10" r:id="rId4" imgW="3770261" imgH="2695753" progId="Prism10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97683" y="-55335"/>
                        <a:ext cx="3770313" cy="2695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1547455"/>
              </p:ext>
            </p:extLst>
          </p:nvPr>
        </p:nvGraphicFramePr>
        <p:xfrm>
          <a:off x="1487488" y="2704049"/>
          <a:ext cx="3276600" cy="1781175"/>
        </p:xfrm>
        <a:graphic>
          <a:graphicData uri="http://schemas.openxmlformats.org/drawingml/2006/table">
            <a:tbl>
              <a:tblPr/>
              <a:tblGrid>
                <a:gridCol w="20553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127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065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4279 to 0.31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042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74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graphicFrame>
        <p:nvGraphicFramePr>
          <p:cNvPr id="20" name="Tab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8153902"/>
              </p:ext>
            </p:extLst>
          </p:nvPr>
        </p:nvGraphicFramePr>
        <p:xfrm>
          <a:off x="7608888" y="2674156"/>
          <a:ext cx="3275012" cy="1781175"/>
        </p:xfrm>
        <a:graphic>
          <a:graphicData uri="http://schemas.openxmlformats.org/drawingml/2006/table">
            <a:tbl>
              <a:tblPr/>
              <a:tblGrid>
                <a:gridCol w="20543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0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11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4012 to 0.19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13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46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5307FE6-FB87-416E-7C87-0D6764DDFB2B}"/>
              </a:ext>
            </a:extLst>
          </p:cNvPr>
          <p:cNvSpPr txBox="1"/>
          <p:nvPr/>
        </p:nvSpPr>
        <p:spPr>
          <a:xfrm>
            <a:off x="1872616" y="2332952"/>
            <a:ext cx="21222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HbA1c (mmol/mol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494910E-D7BC-7799-BE68-13BFDA8130A6}"/>
              </a:ext>
            </a:extLst>
          </p:cNvPr>
          <p:cNvSpPr txBox="1"/>
          <p:nvPr/>
        </p:nvSpPr>
        <p:spPr>
          <a:xfrm rot="16200000">
            <a:off x="17025" y="985787"/>
            <a:ext cx="21222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Urine BCL-XS/BCL-X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7E6CC63-67E6-1AEC-681C-CC0915515140}"/>
              </a:ext>
            </a:extLst>
          </p:cNvPr>
          <p:cNvSpPr txBox="1"/>
          <p:nvPr/>
        </p:nvSpPr>
        <p:spPr>
          <a:xfrm rot="16200000">
            <a:off x="5987519" y="1031010"/>
            <a:ext cx="237802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Leukocyte BCL-XS/BCL-XL</a:t>
            </a:r>
          </a:p>
        </p:txBody>
      </p:sp>
    </p:spTree>
    <p:extLst>
      <p:ext uri="{BB962C8B-B14F-4D97-AF65-F5344CB8AC3E}">
        <p14:creationId xmlns:p14="http://schemas.microsoft.com/office/powerpoint/2010/main" val="40709419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2C4A7215-F0D6-FF06-21D8-008AC9C7A0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5505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AF9459-0F0D-E2B1-72FB-B96C28D2DBC6}"/>
              </a:ext>
            </a:extLst>
          </p:cNvPr>
          <p:cNvSpPr txBox="1"/>
          <p:nvPr/>
        </p:nvSpPr>
        <p:spPr>
          <a:xfrm>
            <a:off x="1612232" y="449981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B36E3D-65EE-BF9A-E05E-EDE0B2B15799}"/>
              </a:ext>
            </a:extLst>
          </p:cNvPr>
          <p:cNvSpPr txBox="1"/>
          <p:nvPr/>
        </p:nvSpPr>
        <p:spPr>
          <a:xfrm>
            <a:off x="782052" y="4499810"/>
            <a:ext cx="1062789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. 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BCL-XS/BCL-XL ratio from urine sediment does not correlate with fasting glucos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NA was obtained from RNA extracted from sediments of urine collected from patients overnight. RT-PCR was performed using BCL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calculate the BCL-XS/BCL-XL ratio. A graph of fasting glucose against the urinary sediment BCL-XS/BCL-XL ratio was generated using GraphPad prism. Pearson correlation analysis and a linear regression analysis were performed (r = -0.220, ns p = 0.292, n = 25 overnight urine samples)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CL-XS/BCL-XL ratio in leucocytes showed no correlation with fasting glucos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NA was obtained from RNA extracted from leucocytes. RTPCR was performed using BCL-X primers to amplify the long and short isoforms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analys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used to calculate the BCL-XS/BCL-XL ratio. A graph of fasting glucose against the leucocyte BCL-XS/BCL-XL ratio was generated using GraphPad prism. Data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sing Pearson correlation analysis and linear regression (r = -0.076, ns p = 0.618, n = 45 blood samples)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F24803-FC66-A973-79A1-D462827C20BF}"/>
              </a:ext>
            </a:extLst>
          </p:cNvPr>
          <p:cNvSpPr txBox="1"/>
          <p:nvPr/>
        </p:nvSpPr>
        <p:spPr>
          <a:xfrm>
            <a:off x="78642" y="9966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110842-629C-90C0-F747-C363BFC87823}"/>
              </a:ext>
            </a:extLst>
          </p:cNvPr>
          <p:cNvSpPr txBox="1"/>
          <p:nvPr/>
        </p:nvSpPr>
        <p:spPr>
          <a:xfrm>
            <a:off x="6173022" y="9966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A255A161-3D83-814C-0D98-C87AC5E98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5618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6DF8036D-B58C-F9C1-8141-73C3AC0630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3090" y="115138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4">
            <a:extLst>
              <a:ext uri="{FF2B5EF4-FFF2-40B4-BE49-F238E27FC236}">
                <a16:creationId xmlns:a16="http://schemas.microsoft.com/office/drawing/2014/main" id="{31D0FF83-0EAE-DAB8-5510-29DE8FA0A9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12214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275E3C63-25BE-05B8-33AA-D8AF863E6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2831" y="93846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4">
            <a:extLst>
              <a:ext uri="{FF2B5EF4-FFF2-40B4-BE49-F238E27FC236}">
                <a16:creationId xmlns:a16="http://schemas.microsoft.com/office/drawing/2014/main" id="{CD407350-9602-BF5E-3FDB-F818E14214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377" y="11069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1933029"/>
              </p:ext>
            </p:extLst>
          </p:nvPr>
        </p:nvGraphicFramePr>
        <p:xfrm>
          <a:off x="7015071" y="-48422"/>
          <a:ext cx="3773487" cy="2700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773502" imgH="2700075" progId="Prism10.Document">
                  <p:embed/>
                </p:oleObj>
              </mc:Choice>
              <mc:Fallback>
                <p:oleObj name="Prism 10" r:id="rId2" imgW="3773502" imgH="2700075" progId="Prism10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15071" y="-48422"/>
                        <a:ext cx="3773487" cy="2700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1" name="Picture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6874" y="-69445"/>
            <a:ext cx="3780000" cy="2703943"/>
          </a:xfrm>
          <a:prstGeom prst="rect">
            <a:avLst/>
          </a:prstGeom>
        </p:spPr>
      </p:pic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6240900"/>
              </p:ext>
            </p:extLst>
          </p:nvPr>
        </p:nvGraphicFramePr>
        <p:xfrm>
          <a:off x="1487488" y="2690118"/>
          <a:ext cx="3276600" cy="1781175"/>
        </p:xfrm>
        <a:graphic>
          <a:graphicData uri="http://schemas.openxmlformats.org/drawingml/2006/table">
            <a:tbl>
              <a:tblPr/>
              <a:tblGrid>
                <a:gridCol w="20553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127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21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5657 to 0.19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48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29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7009135"/>
              </p:ext>
            </p:extLst>
          </p:nvPr>
        </p:nvGraphicFramePr>
        <p:xfrm>
          <a:off x="7608888" y="2674155"/>
          <a:ext cx="3302000" cy="1781175"/>
        </p:xfrm>
        <a:graphic>
          <a:graphicData uri="http://schemas.openxmlformats.org/drawingml/2006/table">
            <a:tbl>
              <a:tblPr/>
              <a:tblGrid>
                <a:gridCol w="189339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086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earson 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076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-0.3619 to 0.22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R squar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0058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(two-tailed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0.61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P value 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Significant? (alpha = 0.0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effectLst/>
                          <a:latin typeface="Arial" panose="020B0604020202020204" pitchFamily="34" charset="0"/>
                        </a:rPr>
                        <a:t>Number of XY Pair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4391741-2D1D-45B6-FB11-6269971F8272}"/>
              </a:ext>
            </a:extLst>
          </p:cNvPr>
          <p:cNvSpPr txBox="1"/>
          <p:nvPr/>
        </p:nvSpPr>
        <p:spPr>
          <a:xfrm rot="16200000">
            <a:off x="6006437" y="1031010"/>
            <a:ext cx="237802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Leukocyte BCL-XS/BCL-X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A2E53A2-AFC7-A23E-132E-82FD65304495}"/>
              </a:ext>
            </a:extLst>
          </p:cNvPr>
          <p:cNvSpPr txBox="1"/>
          <p:nvPr/>
        </p:nvSpPr>
        <p:spPr>
          <a:xfrm rot="16200000">
            <a:off x="17025" y="985787"/>
            <a:ext cx="21222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Urine BCL-XS/BCL-X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8F39FDA-768D-74E3-1F13-9C9326346894}"/>
              </a:ext>
            </a:extLst>
          </p:cNvPr>
          <p:cNvSpPr txBox="1"/>
          <p:nvPr/>
        </p:nvSpPr>
        <p:spPr>
          <a:xfrm>
            <a:off x="1872616" y="2332952"/>
            <a:ext cx="21222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asting Glucose (mmol/L)</a:t>
            </a:r>
          </a:p>
        </p:txBody>
      </p:sp>
    </p:spTree>
    <p:extLst>
      <p:ext uri="{BB962C8B-B14F-4D97-AF65-F5344CB8AC3E}">
        <p14:creationId xmlns:p14="http://schemas.microsoft.com/office/powerpoint/2010/main" val="4007226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912a5d77-fb98-4eee-af32-1334d8f04a53}" enabled="0" method="" siteId="{912a5d77-fb98-4eee-af32-1334d8f04a5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6730</TotalTime>
  <Words>2175</Words>
  <Application>Microsoft Office PowerPoint</Application>
  <PresentationFormat>Widescreen</PresentationFormat>
  <Paragraphs>173</Paragraphs>
  <Slides>1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GraphPad Prism Project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tean, Seb</dc:creator>
  <cp:lastModifiedBy>Meg</cp:lastModifiedBy>
  <cp:revision>81</cp:revision>
  <dcterms:created xsi:type="dcterms:W3CDTF">2023-11-07T17:41:18Z</dcterms:created>
  <dcterms:modified xsi:type="dcterms:W3CDTF">2025-08-07T15:42:39Z</dcterms:modified>
</cp:coreProperties>
</file>